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tif" ContentType="image/tiff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58" r:id="rId3"/>
    <p:sldId id="259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06"/>
    <p:restoredTop sz="94646"/>
  </p:normalViewPr>
  <p:slideViewPr>
    <p:cSldViewPr snapToGrid="0" snapToObjects="1">
      <p:cViewPr varScale="1">
        <p:scale>
          <a:sx n="99" d="100"/>
          <a:sy n="99" d="100"/>
        </p:scale>
        <p:origin x="192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AU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F57FD7-D6B3-3C44-AD1B-EC499EB6AE01}" type="datetimeFigureOut">
              <a:rPr lang="en-US" smtClean="0"/>
              <a:t>6/14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485983-B5DD-7749-BD03-4F42220898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76117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F57FD7-D6B3-3C44-AD1B-EC499EB6AE01}" type="datetimeFigureOut">
              <a:rPr lang="en-US" smtClean="0"/>
              <a:t>6/14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485983-B5DD-7749-BD03-4F42220898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86805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F57FD7-D6B3-3C44-AD1B-EC499EB6AE01}" type="datetimeFigureOut">
              <a:rPr lang="en-US" smtClean="0"/>
              <a:t>6/14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485983-B5DD-7749-BD03-4F42220898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75831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F57FD7-D6B3-3C44-AD1B-EC499EB6AE01}" type="datetimeFigureOut">
              <a:rPr lang="en-US" smtClean="0"/>
              <a:t>6/14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485983-B5DD-7749-BD03-4F42220898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08185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F57FD7-D6B3-3C44-AD1B-EC499EB6AE01}" type="datetimeFigureOut">
              <a:rPr lang="en-US" smtClean="0"/>
              <a:t>6/14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485983-B5DD-7749-BD03-4F42220898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69327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F57FD7-D6B3-3C44-AD1B-EC499EB6AE01}" type="datetimeFigureOut">
              <a:rPr lang="en-US" smtClean="0"/>
              <a:t>6/14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485983-B5DD-7749-BD03-4F42220898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4286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F57FD7-D6B3-3C44-AD1B-EC499EB6AE01}" type="datetimeFigureOut">
              <a:rPr lang="en-US" smtClean="0"/>
              <a:t>6/14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485983-B5DD-7749-BD03-4F42220898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88426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F57FD7-D6B3-3C44-AD1B-EC499EB6AE01}" type="datetimeFigureOut">
              <a:rPr lang="en-US" smtClean="0"/>
              <a:t>6/14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485983-B5DD-7749-BD03-4F42220898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95444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F57FD7-D6B3-3C44-AD1B-EC499EB6AE01}" type="datetimeFigureOut">
              <a:rPr lang="en-US" smtClean="0"/>
              <a:t>6/14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485983-B5DD-7749-BD03-4F42220898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17032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F57FD7-D6B3-3C44-AD1B-EC499EB6AE01}" type="datetimeFigureOut">
              <a:rPr lang="en-US" smtClean="0"/>
              <a:t>6/14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485983-B5DD-7749-BD03-4F42220898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07317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F57FD7-D6B3-3C44-AD1B-EC499EB6AE01}" type="datetimeFigureOut">
              <a:rPr lang="en-US" smtClean="0"/>
              <a:t>6/14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485983-B5DD-7749-BD03-4F42220898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67537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F57FD7-D6B3-3C44-AD1B-EC499EB6AE01}" type="datetimeFigureOut">
              <a:rPr lang="en-US" smtClean="0"/>
              <a:t>6/14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485983-B5DD-7749-BD03-4F42220898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76013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ti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.tif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72435" y="482600"/>
            <a:ext cx="7081413" cy="4731760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1244957" y="5497695"/>
            <a:ext cx="9921025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AU" smtClean="0">
                <a:latin typeface="Times New Roman" charset="0"/>
                <a:ea typeface="DengXian" charset="-122"/>
                <a:cs typeface="Times New Roman" charset="0"/>
              </a:rPr>
              <a:t>F</a:t>
            </a:r>
            <a:r>
              <a:rPr lang="en-AU" smtClean="0">
                <a:effectLst/>
                <a:latin typeface="Times New Roman" charset="0"/>
                <a:ea typeface="DengXian" charset="-122"/>
                <a:cs typeface="Times New Roman" charset="0"/>
              </a:rPr>
              <a:t>igure S1</a:t>
            </a:r>
            <a:r>
              <a:rPr lang="en-AU" dirty="0" smtClean="0">
                <a:effectLst/>
                <a:latin typeface="Times New Roman" charset="0"/>
                <a:ea typeface="DengXian" charset="-122"/>
                <a:cs typeface="Times New Roman" charset="0"/>
              </a:rPr>
              <a:t>. Scatter plots of significant RSFC-reading correlations in children and adults. </a:t>
            </a:r>
            <a:endParaRPr lang="en-AU" dirty="0">
              <a:effectLst/>
              <a:latin typeface="Calibri" charset="0"/>
              <a:ea typeface="DengXian" charset="-122"/>
              <a:cs typeface="Times New Roman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9559059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34991" y="375634"/>
            <a:ext cx="6113527" cy="3758484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1000259" y="4303158"/>
            <a:ext cx="10513454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AU" dirty="0">
                <a:latin typeface="Times New Roman" charset="0"/>
                <a:ea typeface="DengXian" charset="-122"/>
                <a:cs typeface="Times New Roman" charset="0"/>
              </a:rPr>
              <a:t>F</a:t>
            </a:r>
            <a:r>
              <a:rPr lang="en-AU" dirty="0" smtClean="0">
                <a:effectLst/>
                <a:latin typeface="Times New Roman" charset="0"/>
                <a:ea typeface="DengXian" charset="-122"/>
                <a:cs typeface="Times New Roman" charset="0"/>
              </a:rPr>
              <a:t>igure </a:t>
            </a:r>
            <a:r>
              <a:rPr lang="en-AU" dirty="0" smtClean="0">
                <a:effectLst/>
                <a:latin typeface="Times New Roman" charset="0"/>
                <a:ea typeface="DengXian" charset="-122"/>
                <a:cs typeface="Times New Roman" charset="0"/>
              </a:rPr>
              <a:t>S2. </a:t>
            </a:r>
            <a:r>
              <a:rPr lang="en-AU" dirty="0" smtClean="0">
                <a:effectLst/>
                <a:latin typeface="Times New Roman" charset="0"/>
                <a:ea typeface="DengXian" charset="-122"/>
                <a:cs typeface="Times New Roman" charset="0"/>
              </a:rPr>
              <a:t>Two separate clusters of the writing area based on nine fMRI and TMS studies on writing (left) and the locations of </a:t>
            </a:r>
            <a:r>
              <a:rPr lang="en-AU" dirty="0" err="1" smtClean="0">
                <a:effectLst/>
                <a:latin typeface="Times New Roman" charset="0"/>
                <a:ea typeface="DengXian" charset="-122"/>
                <a:cs typeface="Times New Roman" charset="0"/>
              </a:rPr>
              <a:t>LpMFG</a:t>
            </a:r>
            <a:r>
              <a:rPr lang="en-AU" dirty="0" smtClean="0">
                <a:effectLst/>
                <a:latin typeface="Times New Roman" charset="0"/>
                <a:ea typeface="DengXian" charset="-122"/>
                <a:cs typeface="Times New Roman" charset="0"/>
              </a:rPr>
              <a:t> in children and adults (right). Green, children’s cluster; blue, adults’ cluster; red, locations of the writing area in the literature. </a:t>
            </a:r>
            <a:r>
              <a:rPr lang="en-AU" dirty="0" smtClean="0">
                <a:effectLst/>
                <a:latin typeface="Calibri" charset="0"/>
                <a:ea typeface="DengXian" charset="-122"/>
                <a:cs typeface="Times New Roman" charset="0"/>
              </a:rPr>
              <a:t> </a:t>
            </a:r>
            <a:endParaRPr lang="en-AU" dirty="0">
              <a:effectLst/>
              <a:latin typeface="Calibri" charset="0"/>
              <a:ea typeface="DengXian" charset="-122"/>
              <a:cs typeface="Times New Roman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1865082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50952" y="765933"/>
            <a:ext cx="7048350" cy="4455147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1064654" y="5365974"/>
            <a:ext cx="9611932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AU" dirty="0">
                <a:latin typeface="Times New Roman" charset="0"/>
                <a:ea typeface="DengXian" charset="-122"/>
                <a:cs typeface="Times New Roman" charset="0"/>
              </a:rPr>
              <a:t>F</a:t>
            </a:r>
            <a:r>
              <a:rPr lang="en-AU" dirty="0" smtClean="0">
                <a:effectLst/>
                <a:latin typeface="Times New Roman" charset="0"/>
                <a:ea typeface="DengXian" charset="-122"/>
                <a:cs typeface="Times New Roman" charset="0"/>
              </a:rPr>
              <a:t>igure </a:t>
            </a:r>
            <a:r>
              <a:rPr lang="en-AU" dirty="0" smtClean="0">
                <a:effectLst/>
                <a:latin typeface="Times New Roman" charset="0"/>
                <a:ea typeface="DengXian" charset="-122"/>
                <a:cs typeface="Times New Roman" charset="0"/>
              </a:rPr>
              <a:t>S3. </a:t>
            </a:r>
            <a:r>
              <a:rPr lang="en-AU" dirty="0" smtClean="0">
                <a:effectLst/>
                <a:latin typeface="Times New Roman" charset="0"/>
                <a:ea typeface="DengXian" charset="-122"/>
                <a:cs typeface="Times New Roman" charset="0"/>
              </a:rPr>
              <a:t>Scatter plots of significant GCA-reading correlations in children and adults. </a:t>
            </a:r>
            <a:endParaRPr lang="en-AU" dirty="0">
              <a:effectLst/>
              <a:latin typeface="Calibri" charset="0"/>
              <a:ea typeface="DengXian" charset="-122"/>
              <a:cs typeface="Times New Roman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456987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7</TotalTime>
  <Words>84</Words>
  <Application>Microsoft Macintosh PowerPoint</Application>
  <PresentationFormat>Widescreen</PresentationFormat>
  <Paragraphs>3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9" baseType="lpstr">
      <vt:lpstr>Arial</vt:lpstr>
      <vt:lpstr>Calibri</vt:lpstr>
      <vt:lpstr>Calibri Light</vt:lpstr>
      <vt:lpstr>DengXian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u Li</dc:creator>
  <cp:lastModifiedBy>Yu Li</cp:lastModifiedBy>
  <cp:revision>4</cp:revision>
  <dcterms:created xsi:type="dcterms:W3CDTF">2017-04-30T16:14:03Z</dcterms:created>
  <dcterms:modified xsi:type="dcterms:W3CDTF">2017-06-14T05:52:13Z</dcterms:modified>
</cp:coreProperties>
</file>